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D73EB7-D569-45B6-8318-D2629848AAF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76AB3D-6DBB-4BCC-B897-AE40847152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5AF4F5-A602-400C-91F8-83551A1DE6C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71ABE7-66A8-4166-9E61-A8DD1B26D67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0BF5C6-F76E-4A2C-8C6C-0E98068F54E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4569A5-9340-4FD0-8715-8A1F48F754E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F21C0B-B8A2-4C1D-80A7-9CF231A4F79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186DBA-2354-4680-B069-775743386C4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6E1A28-58CC-47A1-86E8-914E258337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0AFD61-B493-4CB8-85F2-89A2D6B692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0D84C7-D30E-4F21-921F-24BD1770DF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1F966A-295D-46A1-A23E-05C4151184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7EC33E6-2362-4C36-B81F-8A6520A659E9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4648320" y="1954080"/>
          <a:ext cx="4495680" cy="33894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648320" y="1954080"/>
                    <a:ext cx="4495680" cy="3389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3" name=""/>
          <p:cNvGraphicFramePr/>
          <p:nvPr/>
        </p:nvGraphicFramePr>
        <p:xfrm>
          <a:off x="76320" y="1806480"/>
          <a:ext cx="4495680" cy="363852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4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76320" y="1806480"/>
                    <a:ext cx="4495680" cy="3638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5" name=""/>
          <p:cNvSpPr/>
          <p:nvPr/>
        </p:nvSpPr>
        <p:spPr>
          <a:xfrm>
            <a:off x="6633000" y="6080040"/>
            <a:ext cx="7354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Times New Roman"/>
              </a:rPr>
              <a:t>Repressed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Times New Roman"/>
              </a:rPr>
              <a:t>&lt; 5X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8138160" y="6080040"/>
            <a:ext cx="6228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Times New Roman"/>
              </a:rPr>
              <a:t>Induced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Times New Roman"/>
              </a:rPr>
              <a:t>&gt;5X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47" name=""/>
          <p:cNvGraphicFramePr/>
          <p:nvPr/>
        </p:nvGraphicFramePr>
        <p:xfrm>
          <a:off x="7162920" y="5992920"/>
          <a:ext cx="1143000" cy="10296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48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7162920" y="5992920"/>
                    <a:ext cx="1143000" cy="102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pSp>
        <p:nvGrpSpPr>
          <p:cNvPr id="49" name=""/>
          <p:cNvGrpSpPr/>
          <p:nvPr/>
        </p:nvGrpSpPr>
        <p:grpSpPr>
          <a:xfrm>
            <a:off x="4648320" y="903960"/>
            <a:ext cx="798480" cy="1077120"/>
            <a:chOff x="4648320" y="903960"/>
            <a:chExt cx="798480" cy="1077120"/>
          </a:xfrm>
        </p:grpSpPr>
        <p:sp>
          <p:nvSpPr>
            <p:cNvPr id="50" name=""/>
            <p:cNvSpPr/>
            <p:nvPr/>
          </p:nvSpPr>
          <p:spPr>
            <a:xfrm>
              <a:off x="4648320" y="190512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5105520" y="190512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4648320" y="190512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5137200" y="190512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5365800" y="190512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5137200" y="190512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"/>
            <p:cNvSpPr/>
            <p:nvPr/>
          </p:nvSpPr>
          <p:spPr>
            <a:xfrm rot="16200000">
              <a:off x="4402440" y="1225800"/>
              <a:ext cx="981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4 depletion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Wyrick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Times New Roman"/>
                </a:rPr>
                <a:t>et al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., 1999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"/>
            <p:cNvSpPr/>
            <p:nvPr/>
          </p:nvSpPr>
          <p:spPr>
            <a:xfrm rot="16254600">
              <a:off x="4892040" y="1326960"/>
              <a:ext cx="7599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8-MOP/UVA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(mean values)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58" name=""/>
          <p:cNvGrpSpPr/>
          <p:nvPr/>
        </p:nvGrpSpPr>
        <p:grpSpPr>
          <a:xfrm>
            <a:off x="139680" y="773640"/>
            <a:ext cx="779400" cy="1065960"/>
            <a:chOff x="139680" y="773640"/>
            <a:chExt cx="779400" cy="1065960"/>
          </a:xfrm>
        </p:grpSpPr>
        <p:sp>
          <p:nvSpPr>
            <p:cNvPr id="59" name=""/>
            <p:cNvSpPr/>
            <p:nvPr/>
          </p:nvSpPr>
          <p:spPr>
            <a:xfrm>
              <a:off x="139680" y="176364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596880" y="176364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139680" y="176364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628560" y="176364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857160" y="176364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628560" y="176364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"/>
            <p:cNvSpPr/>
            <p:nvPr/>
          </p:nvSpPr>
          <p:spPr>
            <a:xfrm rot="16200000">
              <a:off x="-107280" y="1095480"/>
              <a:ext cx="981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4 depletion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Wyrick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Times New Roman"/>
                </a:rPr>
                <a:t>et al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., 1999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"/>
            <p:cNvSpPr/>
            <p:nvPr/>
          </p:nvSpPr>
          <p:spPr>
            <a:xfrm rot="16254600">
              <a:off x="364320" y="1177560"/>
              <a:ext cx="7599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8-MOP/UVA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(mean values)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4-05T12:36:53Z</dcterms:created>
  <dc:creator>Curie Orsay</dc:creator>
  <dc:description/>
  <dc:language>en-US</dc:language>
  <cp:lastModifiedBy>Curie Orsay</cp:lastModifiedBy>
  <cp:lastPrinted>2006-12-19T13:08:34Z</cp:lastPrinted>
  <dcterms:modified xsi:type="dcterms:W3CDTF">2007-02-27T16:44:24Z</dcterms:modified>
  <cp:revision>15</cp:revision>
  <dc:subject/>
  <dc:title>Présentation PowerPoint</dc:title>
</cp:coreProperties>
</file>